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8CD81A3-17C6-494B-B074-75A4CE5A6E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E6E0868-DE85-4022-BD9B-B30E853960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CDB4728-1428-4013-BD96-D25E5414A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0C2A13-BCB2-4696-A656-11438141D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ACEE22C-EC66-4CC9-9AE8-1D75F5CAF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26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1D87C2-867E-48D8-BDF9-D62850C283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4C4EEBA-D261-437B-93A8-AF7F5D6A1B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010597-E2E6-4A85-A91B-E288309B6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6DCD58-051F-4409-8DDC-B0CA92230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E637907-44FF-4504-9A33-7BC603B3F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4473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1963BE8-B2B2-4273-AF66-3E3AC53759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366C337-09EF-42C1-BBA5-8E4C339FEA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1627515-2275-44A1-AFC9-D7429AD01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D8B9D55-7EA8-4C37-8FAA-9EDBE2EA0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3B87CA-40E7-4893-BD8A-A9E0C2920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9122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81ACFD-FAC0-41E8-8F18-DD074A7885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8092D35-D2EB-451E-94E9-D40D31A9E0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B1A6EE-1C5B-48CA-992E-699F227A2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93D5921-0BDC-4488-A3D3-F59700947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FA2B646-9F87-4ABC-B797-DEF34A7C2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412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8ABDB7-62BD-4440-B8AC-133677B64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B4E4802-9A52-48C4-A7AF-4718AAE77C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2A21F8-1296-4CD5-A513-538C2C37B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762DB0E-39A4-4405-A05F-243479F28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C34CE6-A469-4D97-AA68-9AECDEF3F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019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729695-05AC-4BF0-8D27-DFA9A27775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24E118A-E65C-4F87-8F28-FFE146380C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7C088DA-9C31-467B-94A4-C47E228D57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6B8B70-6420-4DB0-AEBD-3154D5B46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0CD5F28-C8A4-4114-BED6-F1BAC191A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AB07FA-24AE-4AC6-BEB8-E888E537C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459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A82A1C-C7F4-4C1A-93D1-82C78E5EA4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E762F8-1555-4923-8CA2-F50A80A03E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081D462-FFBC-4B20-A6BB-688D8EB583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26D2712-2CD5-4653-84CA-8AC4A7D6B9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A599CA7-8348-4873-8DD2-9EF33A610D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D2DB7E6-4A20-435D-BAF0-0CE019713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C9FF629-AB0B-470D-8470-F57E2230F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79DD4D0-75B4-46B7-824E-B73F52403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5056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E4E6D8-E5A3-413A-B880-855E99886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B1455C0-6E76-4C26-9464-BF378BD5F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4AC1868-9743-4FCB-A078-608C495AD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8E848F1-1A6D-4E5F-8AB3-3B0DF624A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0670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62D2F0E-5C2B-48D0-B7A8-4E93BF168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5100CD3-9677-4FA3-A15D-566E09FD3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1CD649A-301A-4AD8-8222-B0AB20912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8269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3BB266B-7C60-4429-9927-549B3FEF8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B1E7B59-0CCE-4088-B94A-8A196B3899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A56A178-F42B-4C76-BB9D-D368ECCF3E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CB73CE3-BDF1-4B79-8E53-007273FD6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B9F20BF-B8E4-4B06-9A17-EF883135F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15F212D-6660-4141-90CC-547CB580A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0022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842EDA0-9B02-4AE3-AC38-202370621B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EA15976-8789-4F23-B9B8-9AFD9B1530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4BB4DB4-B153-44FB-9A41-21C4343030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43C3BAE-BFE5-456B-8AAC-7670AE818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C74DC71-2DA9-40B8-BAA3-3216EE877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8CED691-BC4D-43D7-A94A-6EDAFFD9F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0104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78814CE-BCEE-4414-A58E-3CBADCC11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21A34EA-CD73-46A7-92B9-CEAF7B8DF9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B02DBFA-2E12-4907-93EF-01339E59DD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AC7B6-D323-4ABA-B4BC-FB5724270E08}" type="datetimeFigureOut">
              <a:rPr lang="fr-FR" smtClean="0"/>
              <a:t>14/10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3FB649-2D6C-4953-9CE2-EFA5079E88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52144C8-50FB-47E3-B8D5-38590755B0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E75C7-CE55-4C8E-A9C6-C56F2AA8E4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9812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B8C10543-835B-447D-8064-F8EF00D97BA7}"/>
              </a:ext>
            </a:extLst>
          </p:cNvPr>
          <p:cNvSpPr/>
          <p:nvPr/>
        </p:nvSpPr>
        <p:spPr>
          <a:xfrm>
            <a:off x="2559728" y="1409122"/>
            <a:ext cx="6096000" cy="38215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07000"/>
              </a:lnSpc>
              <a:spcAft>
                <a:spcPts val="1000"/>
              </a:spcAft>
            </a:pPr>
            <a:r>
              <a:rPr lang="en-GB" sz="900" i="1" dirty="0">
                <a:solidFill>
                  <a:srgbClr val="44546A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S: Kaplan-Meier graph of overall survival in 146 patients with differentiated thyroid carcinomas and bone metastases depending on complete-bone metastasis response. </a:t>
            </a:r>
            <a:endParaRPr lang="fr-FR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D154145F-9C20-4524-BDCB-69FBFA08D41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9350" y="1928970"/>
            <a:ext cx="3542030" cy="323088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0315608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ANNIN Arnaud</dc:creator>
  <cp:lastModifiedBy>JANNIN Arnaud</cp:lastModifiedBy>
  <cp:revision>1</cp:revision>
  <dcterms:created xsi:type="dcterms:W3CDTF">2021-10-14T14:24:42Z</dcterms:created>
  <dcterms:modified xsi:type="dcterms:W3CDTF">2021-10-14T14:25:11Z</dcterms:modified>
</cp:coreProperties>
</file>